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26" r:id="rId2"/>
  </p:sldIdLst>
  <p:sldSz cx="9601200" cy="12801600" type="A3"/>
  <p:notesSz cx="6858000" cy="9144000"/>
  <p:defaultTextStyle>
    <a:defPPr>
      <a:defRPr lang="en-US"/>
    </a:defPPr>
    <a:lvl1pPr marL="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 userDrawn="1">
          <p15:clr>
            <a:srgbClr val="A4A3A4"/>
          </p15:clr>
        </p15:guide>
        <p15:guide id="2" pos="30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300"/>
    <a:srgbClr val="0432FF"/>
    <a:srgbClr val="FF0100"/>
    <a:srgbClr val="FF9700"/>
    <a:srgbClr val="FEFF1C"/>
    <a:srgbClr val="FFB502"/>
    <a:srgbClr val="FFD302"/>
    <a:srgbClr val="FCB301"/>
    <a:srgbClr val="F69102"/>
    <a:srgbClr val="FFFF1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13"/>
    <p:restoredTop sz="95161"/>
  </p:normalViewPr>
  <p:slideViewPr>
    <p:cSldViewPr snapToGrid="0" snapToObjects="1">
      <p:cViewPr varScale="1">
        <p:scale>
          <a:sx n="55" d="100"/>
          <a:sy n="55" d="100"/>
        </p:scale>
        <p:origin x="3144" y="192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82A022-C9F4-0148-975C-F94539B6FB3D}" type="datetimeFigureOut">
              <a:rPr lang="en-US" smtClean="0"/>
              <a:t>7/12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5F2F5C-3AD8-114A-9235-54C4AB861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9318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556F7-2C12-5140-B74C-9CF7B726B924}" type="datetimeFigureOut">
              <a:rPr lang="en-US" smtClean="0"/>
              <a:t>7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473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6" name="Picture 125">
            <a:extLst>
              <a:ext uri="{FF2B5EF4-FFF2-40B4-BE49-F238E27FC236}">
                <a16:creationId xmlns:a16="http://schemas.microsoft.com/office/drawing/2014/main" id="{2F898877-7106-B59F-09C6-1C1800A1BE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4400" y="516992"/>
            <a:ext cx="7772400" cy="7267334"/>
          </a:xfrm>
          <a:prstGeom prst="rect">
            <a:avLst/>
          </a:prstGeom>
        </p:spPr>
      </p:pic>
      <p:sp>
        <p:nvSpPr>
          <p:cNvPr id="127" name="TextBox 126">
            <a:extLst>
              <a:ext uri="{FF2B5EF4-FFF2-40B4-BE49-F238E27FC236}">
                <a16:creationId xmlns:a16="http://schemas.microsoft.com/office/drawing/2014/main" id="{7CD0624D-70B2-CA5D-C4A3-341B6CBB06D7}"/>
              </a:ext>
            </a:extLst>
          </p:cNvPr>
          <p:cNvSpPr txBox="1"/>
          <p:nvPr/>
        </p:nvSpPr>
        <p:spPr>
          <a:xfrm>
            <a:off x="201753" y="7784326"/>
            <a:ext cx="919769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Expression patterns of cold-stress-specific genes in the leaves on “Moneymaker” plants subjected to 5ºC or 20ºC temperature treatment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ach datapoint represents the average (± SE) of 10 fruits. * indicates a significant difference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)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values are relative 0 d samples and the housekeeping gene was 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lActi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atapoints indicate means (± SE) of three replicate fruit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 letters indicate significant differences in ANOVA (Tukey’s test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).</a:t>
            </a:r>
          </a:p>
        </p:txBody>
      </p:sp>
    </p:spTree>
    <p:extLst>
      <p:ext uri="{BB962C8B-B14F-4D97-AF65-F5344CB8AC3E}">
        <p14:creationId xmlns:p14="http://schemas.microsoft.com/office/powerpoint/2010/main" val="41499511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9648</TotalTime>
  <Words>87</Words>
  <Application>Microsoft Macintosh PowerPoint</Application>
  <PresentationFormat>A3 Paper (297x420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TALO Oscar　Witere</dc:creator>
  <cp:keywords/>
  <dc:description/>
  <cp:lastModifiedBy>Oscar Witere Mitalo</cp:lastModifiedBy>
  <cp:revision>1664</cp:revision>
  <cp:lastPrinted>2022-02-28T04:45:31Z</cp:lastPrinted>
  <dcterms:created xsi:type="dcterms:W3CDTF">2018-04-12T04:09:11Z</dcterms:created>
  <dcterms:modified xsi:type="dcterms:W3CDTF">2023-07-11T15:16:37Z</dcterms:modified>
  <cp:category/>
</cp:coreProperties>
</file>